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  <p:sldId id="278" r:id="rId3"/>
    <p:sldId id="279" r:id="rId4"/>
    <p:sldId id="27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74E50E7-AF37-66E4-5677-93D469500D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BCE7CEB-A37C-1B93-8126-673CC63F03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C07F878-8333-47A7-733B-38A94A1D3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3DC8494-DC8F-BA44-B8FE-2C9EBECFF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C2D9C1F-4C3A-AA84-86AD-DF2AB2A83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84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8ABF467-CDA7-9C6C-9FBB-AE72A8243A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92EF5C1-A8C6-DF64-526B-85C926D698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04D98C2-80FB-6339-0AF0-C75E6220C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5844F15-081C-0BBF-E78B-56FCC16EF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32FF3D2-A02C-C6DF-FBB4-DF51A8913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237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547C3FC7-5828-A2CE-AA8D-48DE2EE679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CBBD3CF-A990-B198-DB82-B1B18CE5A7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063F875-B889-AA3C-2EA3-965ABEEC9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AF62B0E-24E5-205F-A91C-8D9709E3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FF80C1B-527C-B697-302F-374D6942F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622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3C5E6F4-B78B-773B-0D06-77D38C8C22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D153E4B-E234-8FEA-B333-A5128DF211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882CF6F-A699-2B2E-4664-00267E360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6F98967-D8B4-7004-7B09-15086C477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6746792-4354-488F-D344-D3845E92C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284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897FA1D-B57E-1736-6111-B151986FC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7B54E52-CB71-45E0-9B7F-8D683B241E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08261E7-453D-E7A3-4EE3-0AEF392EB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1395528-2282-2042-7CF3-FCC404DED9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5E5D4A2-4DC2-818A-5F68-C14404B0C5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376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3609E05-5BB5-3F70-9A88-D24DE14385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187E585-C0B2-C0EB-EE66-FB19A0E44F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26396B2-7811-0158-817F-F92F044DB7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4028085-8FFC-B6C9-A885-0D2B99B38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BC3F9FE-4457-A3EF-D5B1-78E4B9AA9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4B1C2D1-304D-D39C-F36F-022408F9C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828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9A0C15E-AFD2-5CEB-034F-7E059B4AE4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CB33D98-0A29-3596-1342-77B19A7FDA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D96D412-4BC8-B56C-90FA-A3F7D5B4AC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550D5C3D-CCF5-7DA9-33DB-B15175BB3A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9134A146-CEFE-A057-AD4A-056275F382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2205107B-003B-2D95-22DC-134519CBD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C6ABA5D7-60E7-0E0B-0154-7CB8C3629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BD6FA2F8-B77D-35EF-CBCE-B9C0B6919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387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51283CD-A035-7276-FBE2-B5ECC21CC0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FFB2FAC1-6D0E-50CC-F74C-DB769150C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D2E20B75-753C-CC22-56C0-9EA8D816A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54B2258D-9803-8881-1B86-99E712043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768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2CA94965-B6E0-1C14-2FC2-D70E18E63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8C3992E4-CF05-7457-92ED-2F859C0EA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72B09E80-9D80-8B8C-087A-33CB7A2B3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363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94391EF-FCAC-5C48-5112-25798311FE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A380DBE-5E68-AAF4-8CE0-93FDD4F5FC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27731C6-4C03-6048-05E3-786CBE80F9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A0F9FA8-3D09-F9B3-F057-3DDDA102A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CF39568-86CC-4DBF-F461-105A81575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56EF015-AC7A-843C-A761-1481005F7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92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6C66353-09E3-A93A-6379-4BCD203CA9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53E854D-A226-0082-89E6-99986C413A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B653892-0989-4A5D-F972-D09ECBB7DE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F95B18E-8C52-E399-1064-052F2901E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0EF7C66-CE58-4AF5-7CCA-93B073760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EAB3C64-1942-2BE2-5E49-CDCD5BDBC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035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D5FEC5D-4227-3C7B-7D3F-8A3FDBCD0C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83D7612-9022-126A-61D0-00F1C48A3B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511C9F9-CB9D-02B5-2951-726C29D099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BD4BF-0D40-40C1-9BA2-6F816E346C0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7621C14-8A6C-1231-EEC2-968C847741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8ECA42A-9B3A-806C-8117-B355931764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4802E-A62A-4F93-853D-ED17F508BE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125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1B0B08F5-5FAC-B532-4B03-D4A1474C0790}"/>
              </a:ext>
            </a:extLst>
          </p:cNvPr>
          <p:cNvSpPr txBox="1"/>
          <p:nvPr/>
        </p:nvSpPr>
        <p:spPr>
          <a:xfrm>
            <a:off x="424996" y="181439"/>
            <a:ext cx="11420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. 1. Complete Western blots of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ecp2</a:t>
            </a:r>
            <a:r>
              <a:rPr lang="en-US" sz="1800" b="1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306C/+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ice hippocampal synaptosome samples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869DC4C8-7D5A-59C8-491A-F32F4056BA96}"/>
              </a:ext>
            </a:extLst>
          </p:cNvPr>
          <p:cNvSpPr/>
          <p:nvPr/>
        </p:nvSpPr>
        <p:spPr>
          <a:xfrm>
            <a:off x="160215" y="2785669"/>
            <a:ext cx="113457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ono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1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A9A7666B-73D7-B23D-0EA3-6A6A0D022721}"/>
              </a:ext>
            </a:extLst>
          </p:cNvPr>
          <p:cNvSpPr/>
          <p:nvPr/>
        </p:nvSpPr>
        <p:spPr>
          <a:xfrm>
            <a:off x="160215" y="2270396"/>
            <a:ext cx="113457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i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2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xmlns="" id="{826FBBF7-95F8-3C08-3529-CDBC1FC7041F}"/>
              </a:ext>
            </a:extLst>
          </p:cNvPr>
          <p:cNvSpPr/>
          <p:nvPr/>
        </p:nvSpPr>
        <p:spPr>
          <a:xfrm>
            <a:off x="5982615" y="3554282"/>
            <a:ext cx="91786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5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" name="Isosceles Triangle 16">
            <a:extLst>
              <a:ext uri="{FF2B5EF4-FFF2-40B4-BE49-F238E27FC236}">
                <a16:creationId xmlns:a16="http://schemas.microsoft.com/office/drawing/2014/main" xmlns="" id="{3F721DC1-66C7-DCCD-807B-1FF397E6C071}"/>
              </a:ext>
            </a:extLst>
          </p:cNvPr>
          <p:cNvSpPr/>
          <p:nvPr/>
        </p:nvSpPr>
        <p:spPr>
          <a:xfrm rot="5400000" flipH="1">
            <a:off x="6831143" y="3720078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Isosceles Triangle 17">
            <a:extLst>
              <a:ext uri="{FF2B5EF4-FFF2-40B4-BE49-F238E27FC236}">
                <a16:creationId xmlns:a16="http://schemas.microsoft.com/office/drawing/2014/main" xmlns="" id="{54A4D27F-351F-63BB-84E5-49B6F681C8F5}"/>
              </a:ext>
            </a:extLst>
          </p:cNvPr>
          <p:cNvSpPr/>
          <p:nvPr/>
        </p:nvSpPr>
        <p:spPr>
          <a:xfrm rot="5400000" flipH="1">
            <a:off x="1289785" y="2951465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Isosceles Triangle 18">
            <a:extLst>
              <a:ext uri="{FF2B5EF4-FFF2-40B4-BE49-F238E27FC236}">
                <a16:creationId xmlns:a16="http://schemas.microsoft.com/office/drawing/2014/main" xmlns="" id="{356EA1C8-FBA0-A016-9BF2-F1649C66B475}"/>
              </a:ext>
            </a:extLst>
          </p:cNvPr>
          <p:cNvSpPr/>
          <p:nvPr/>
        </p:nvSpPr>
        <p:spPr>
          <a:xfrm rot="5400000" flipH="1">
            <a:off x="1289785" y="2436192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13A53122-0AFA-8776-E600-DD0991130F00}"/>
              </a:ext>
            </a:extLst>
          </p:cNvPr>
          <p:cNvSpPr txBox="1"/>
          <p:nvPr/>
        </p:nvSpPr>
        <p:spPr>
          <a:xfrm>
            <a:off x="2379398" y="1540492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EBC65C88-F687-386A-1717-6B22C7EE9FC0}"/>
              </a:ext>
            </a:extLst>
          </p:cNvPr>
          <p:cNvSpPr txBox="1"/>
          <p:nvPr/>
        </p:nvSpPr>
        <p:spPr>
          <a:xfrm>
            <a:off x="3694393" y="1540492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306C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D111CAA5-1ECC-18AF-000E-5347C2207B83}"/>
              </a:ext>
            </a:extLst>
          </p:cNvPr>
          <p:cNvSpPr txBox="1"/>
          <p:nvPr/>
        </p:nvSpPr>
        <p:spPr>
          <a:xfrm>
            <a:off x="4591894" y="1294271"/>
            <a:ext cx="11112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Grm7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KO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xmlns="" id="{7F84155B-38E3-D62D-3D19-F76E6C956A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5760" y="2164046"/>
            <a:ext cx="4317909" cy="256672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50" name="Right Bracket 49">
            <a:extLst>
              <a:ext uri="{FF2B5EF4-FFF2-40B4-BE49-F238E27FC236}">
                <a16:creationId xmlns:a16="http://schemas.microsoft.com/office/drawing/2014/main" xmlns="" id="{49DCFE7A-D6C1-57C8-1351-C64BA6F2F7E7}"/>
              </a:ext>
            </a:extLst>
          </p:cNvPr>
          <p:cNvSpPr/>
          <p:nvPr/>
        </p:nvSpPr>
        <p:spPr>
          <a:xfrm rot="16200000">
            <a:off x="2574813" y="1320862"/>
            <a:ext cx="112834" cy="1249756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ight Bracket 50">
            <a:extLst>
              <a:ext uri="{FF2B5EF4-FFF2-40B4-BE49-F238E27FC236}">
                <a16:creationId xmlns:a16="http://schemas.microsoft.com/office/drawing/2014/main" xmlns="" id="{A92A3E13-6D54-D74E-3813-380439EC07ED}"/>
              </a:ext>
            </a:extLst>
          </p:cNvPr>
          <p:cNvSpPr/>
          <p:nvPr/>
        </p:nvSpPr>
        <p:spPr>
          <a:xfrm rot="16200000">
            <a:off x="4038322" y="1331045"/>
            <a:ext cx="133200" cy="1249756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ight Bracket 51">
            <a:extLst>
              <a:ext uri="{FF2B5EF4-FFF2-40B4-BE49-F238E27FC236}">
                <a16:creationId xmlns:a16="http://schemas.microsoft.com/office/drawing/2014/main" xmlns="" id="{C3E2F03E-F07E-D54B-207D-15731222806D}"/>
              </a:ext>
            </a:extLst>
          </p:cNvPr>
          <p:cNvSpPr/>
          <p:nvPr/>
        </p:nvSpPr>
        <p:spPr>
          <a:xfrm rot="16200000">
            <a:off x="5080894" y="1723553"/>
            <a:ext cx="133201" cy="46474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94AE7CB9-1202-DE3B-AA22-78E9C0E66F44}"/>
              </a:ext>
            </a:extLst>
          </p:cNvPr>
          <p:cNvSpPr txBox="1"/>
          <p:nvPr/>
        </p:nvSpPr>
        <p:spPr>
          <a:xfrm>
            <a:off x="3018468" y="868731"/>
            <a:ext cx="1372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Glu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Blo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D274BA8B-4C97-6889-C409-133006FC517D}"/>
              </a:ext>
            </a:extLst>
          </p:cNvPr>
          <p:cNvSpPr txBox="1"/>
          <p:nvPr/>
        </p:nvSpPr>
        <p:spPr>
          <a:xfrm>
            <a:off x="8666687" y="868731"/>
            <a:ext cx="1514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ubulin Blot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xmlns="" id="{027B7CCC-9513-8A65-2DF3-875AE91BE0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88432" y="2145635"/>
            <a:ext cx="4670579" cy="260355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6C03F316-EECD-93C4-08CD-B26B49ACC2B2}"/>
              </a:ext>
            </a:extLst>
          </p:cNvPr>
          <p:cNvSpPr txBox="1"/>
          <p:nvPr/>
        </p:nvSpPr>
        <p:spPr>
          <a:xfrm>
            <a:off x="8010225" y="1540492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8B874C86-9E5C-DDC5-9730-9BA5BACBC1C9}"/>
              </a:ext>
            </a:extLst>
          </p:cNvPr>
          <p:cNvSpPr txBox="1"/>
          <p:nvPr/>
        </p:nvSpPr>
        <p:spPr>
          <a:xfrm>
            <a:off x="9484112" y="1540492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306C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DEC59CF6-6923-3EE5-047C-D6ADBE0AA490}"/>
              </a:ext>
            </a:extLst>
          </p:cNvPr>
          <p:cNvSpPr txBox="1"/>
          <p:nvPr/>
        </p:nvSpPr>
        <p:spPr>
          <a:xfrm>
            <a:off x="10630190" y="1294271"/>
            <a:ext cx="11112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Grm7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KO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</a:p>
        </p:txBody>
      </p:sp>
      <p:sp>
        <p:nvSpPr>
          <p:cNvPr id="59" name="Right Bracket 58">
            <a:extLst>
              <a:ext uri="{FF2B5EF4-FFF2-40B4-BE49-F238E27FC236}">
                <a16:creationId xmlns:a16="http://schemas.microsoft.com/office/drawing/2014/main" xmlns="" id="{BCE6EA8C-76B7-DBE3-9A6C-69C325DB4956}"/>
              </a:ext>
            </a:extLst>
          </p:cNvPr>
          <p:cNvSpPr/>
          <p:nvPr/>
        </p:nvSpPr>
        <p:spPr>
          <a:xfrm rot="16200000">
            <a:off x="8202454" y="1307894"/>
            <a:ext cx="119206" cy="126932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ight Bracket 59">
            <a:extLst>
              <a:ext uri="{FF2B5EF4-FFF2-40B4-BE49-F238E27FC236}">
                <a16:creationId xmlns:a16="http://schemas.microsoft.com/office/drawing/2014/main" xmlns="" id="{D1D24358-F993-5224-F74F-B938E772B1C2}"/>
              </a:ext>
            </a:extLst>
          </p:cNvPr>
          <p:cNvSpPr/>
          <p:nvPr/>
        </p:nvSpPr>
        <p:spPr>
          <a:xfrm rot="16200000">
            <a:off x="9828041" y="1324673"/>
            <a:ext cx="133200" cy="1249756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ight Bracket 60">
            <a:extLst>
              <a:ext uri="{FF2B5EF4-FFF2-40B4-BE49-F238E27FC236}">
                <a16:creationId xmlns:a16="http://schemas.microsoft.com/office/drawing/2014/main" xmlns="" id="{F25E63CC-DE3C-5E0B-ACDB-CB0DCBC00B9B}"/>
              </a:ext>
            </a:extLst>
          </p:cNvPr>
          <p:cNvSpPr/>
          <p:nvPr/>
        </p:nvSpPr>
        <p:spPr>
          <a:xfrm rot="16200000">
            <a:off x="11119190" y="1717181"/>
            <a:ext cx="133201" cy="46474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17BC8EF-16C2-DA03-FDF2-5EFE42462CFF}"/>
              </a:ext>
            </a:extLst>
          </p:cNvPr>
          <p:cNvSpPr txBox="1"/>
          <p:nvPr/>
        </p:nvSpPr>
        <p:spPr>
          <a:xfrm>
            <a:off x="697972" y="855532"/>
            <a:ext cx="3652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7742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1A9A1166-F025-EAD4-AB26-5B8662E8C7E7}"/>
              </a:ext>
            </a:extLst>
          </p:cNvPr>
          <p:cNvSpPr/>
          <p:nvPr/>
        </p:nvSpPr>
        <p:spPr>
          <a:xfrm>
            <a:off x="168526" y="2785669"/>
            <a:ext cx="113457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ono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1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B2CE357B-F599-DE1C-CCF9-22D994F1DC34}"/>
              </a:ext>
            </a:extLst>
          </p:cNvPr>
          <p:cNvSpPr/>
          <p:nvPr/>
        </p:nvSpPr>
        <p:spPr>
          <a:xfrm>
            <a:off x="168526" y="2270396"/>
            <a:ext cx="113457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i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2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4618A1E6-1F4E-C1D8-564B-F9652795623D}"/>
              </a:ext>
            </a:extLst>
          </p:cNvPr>
          <p:cNvSpPr/>
          <p:nvPr/>
        </p:nvSpPr>
        <p:spPr>
          <a:xfrm>
            <a:off x="6024178" y="3471155"/>
            <a:ext cx="91786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5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" name="Isosceles Triangle 5">
            <a:extLst>
              <a:ext uri="{FF2B5EF4-FFF2-40B4-BE49-F238E27FC236}">
                <a16:creationId xmlns:a16="http://schemas.microsoft.com/office/drawing/2014/main" xmlns="" id="{3D407D5D-B640-C12A-F4E1-772B3AF1E37E}"/>
              </a:ext>
            </a:extLst>
          </p:cNvPr>
          <p:cNvSpPr/>
          <p:nvPr/>
        </p:nvSpPr>
        <p:spPr>
          <a:xfrm rot="5400000" flipH="1">
            <a:off x="6872706" y="3636951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Isosceles Triangle 6">
            <a:extLst>
              <a:ext uri="{FF2B5EF4-FFF2-40B4-BE49-F238E27FC236}">
                <a16:creationId xmlns:a16="http://schemas.microsoft.com/office/drawing/2014/main" xmlns="" id="{2D2A1638-EFD6-8BB5-952A-C1FFE167C73D}"/>
              </a:ext>
            </a:extLst>
          </p:cNvPr>
          <p:cNvSpPr/>
          <p:nvPr/>
        </p:nvSpPr>
        <p:spPr>
          <a:xfrm rot="5400000" flipH="1">
            <a:off x="1140155" y="2951465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Isosceles Triangle 7">
            <a:extLst>
              <a:ext uri="{FF2B5EF4-FFF2-40B4-BE49-F238E27FC236}">
                <a16:creationId xmlns:a16="http://schemas.microsoft.com/office/drawing/2014/main" xmlns="" id="{31929A13-D831-AFB6-95D6-6A26B4C154A8}"/>
              </a:ext>
            </a:extLst>
          </p:cNvPr>
          <p:cNvSpPr/>
          <p:nvPr/>
        </p:nvSpPr>
        <p:spPr>
          <a:xfrm rot="5400000" flipH="1">
            <a:off x="1140155" y="2436192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49EBA04F-41F5-9F62-28F7-F0AF93498F08}"/>
              </a:ext>
            </a:extLst>
          </p:cNvPr>
          <p:cNvSpPr txBox="1"/>
          <p:nvPr/>
        </p:nvSpPr>
        <p:spPr>
          <a:xfrm>
            <a:off x="2868838" y="868731"/>
            <a:ext cx="1372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Glu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B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76CBF83A-1D45-BB38-675A-B6447879DEB7}"/>
              </a:ext>
            </a:extLst>
          </p:cNvPr>
          <p:cNvSpPr txBox="1"/>
          <p:nvPr/>
        </p:nvSpPr>
        <p:spPr>
          <a:xfrm>
            <a:off x="8517057" y="868731"/>
            <a:ext cx="1514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ubulin Blo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2ADCDC76-085D-203E-A5D7-461AA4A33C2A}"/>
              </a:ext>
            </a:extLst>
          </p:cNvPr>
          <p:cNvSpPr txBox="1"/>
          <p:nvPr/>
        </p:nvSpPr>
        <p:spPr>
          <a:xfrm>
            <a:off x="8107086" y="1540492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DB24FFDD-108B-F3FD-5C01-EC63BCF07395}"/>
              </a:ext>
            </a:extLst>
          </p:cNvPr>
          <p:cNvSpPr txBox="1"/>
          <p:nvPr/>
        </p:nvSpPr>
        <p:spPr>
          <a:xfrm>
            <a:off x="9715447" y="1540492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306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B817ADC-AF0E-9A3C-8EE2-B4EB1E48023A}"/>
              </a:ext>
            </a:extLst>
          </p:cNvPr>
          <p:cNvSpPr txBox="1"/>
          <p:nvPr/>
        </p:nvSpPr>
        <p:spPr>
          <a:xfrm>
            <a:off x="10788128" y="1294271"/>
            <a:ext cx="11112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Grm7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KO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</a:p>
        </p:txBody>
      </p:sp>
      <p:sp>
        <p:nvSpPr>
          <p:cNvPr id="14" name="Right Bracket 13">
            <a:extLst>
              <a:ext uri="{FF2B5EF4-FFF2-40B4-BE49-F238E27FC236}">
                <a16:creationId xmlns:a16="http://schemas.microsoft.com/office/drawing/2014/main" xmlns="" id="{BD0F4508-42DA-A4A1-6448-A912E69196F4}"/>
              </a:ext>
            </a:extLst>
          </p:cNvPr>
          <p:cNvSpPr/>
          <p:nvPr/>
        </p:nvSpPr>
        <p:spPr>
          <a:xfrm rot="16200000">
            <a:off x="8304054" y="1140959"/>
            <a:ext cx="109728" cy="164592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ight Bracket 14">
            <a:extLst>
              <a:ext uri="{FF2B5EF4-FFF2-40B4-BE49-F238E27FC236}">
                <a16:creationId xmlns:a16="http://schemas.microsoft.com/office/drawing/2014/main" xmlns="" id="{7D529223-FCE7-B78F-D319-F003EF43B25F}"/>
              </a:ext>
            </a:extLst>
          </p:cNvPr>
          <p:cNvSpPr/>
          <p:nvPr/>
        </p:nvSpPr>
        <p:spPr>
          <a:xfrm rot="16200000">
            <a:off x="10071113" y="1138327"/>
            <a:ext cx="109728" cy="164592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ight Bracket 15">
            <a:extLst>
              <a:ext uri="{FF2B5EF4-FFF2-40B4-BE49-F238E27FC236}">
                <a16:creationId xmlns:a16="http://schemas.microsoft.com/office/drawing/2014/main" xmlns="" id="{7077C384-995F-7550-07E5-A2E944FFDBD6}"/>
              </a:ext>
            </a:extLst>
          </p:cNvPr>
          <p:cNvSpPr/>
          <p:nvPr/>
        </p:nvSpPr>
        <p:spPr>
          <a:xfrm rot="16200000">
            <a:off x="11277128" y="1717181"/>
            <a:ext cx="133201" cy="46474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1F9A7A28-9BF0-A2EC-977B-88B9C2A5E5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6381" y="2182875"/>
            <a:ext cx="4071705" cy="225202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CA101651-A1E1-D7EB-065F-EEB3459DEF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49" r="1133"/>
          <a:stretch/>
        </p:blipFill>
        <p:spPr>
          <a:xfrm>
            <a:off x="7148944" y="2181475"/>
            <a:ext cx="4455621" cy="225342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0C407BB0-7DC1-DFA3-FE1D-84AB8AB23343}"/>
              </a:ext>
            </a:extLst>
          </p:cNvPr>
          <p:cNvSpPr txBox="1"/>
          <p:nvPr/>
        </p:nvSpPr>
        <p:spPr>
          <a:xfrm>
            <a:off x="2310501" y="1543069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5DB3D357-212B-DFF2-E703-7B2F9A88AC8A}"/>
              </a:ext>
            </a:extLst>
          </p:cNvPr>
          <p:cNvSpPr txBox="1"/>
          <p:nvPr/>
        </p:nvSpPr>
        <p:spPr>
          <a:xfrm>
            <a:off x="3700439" y="1534667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306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B64EA47F-0F04-FFC8-1291-DE5B6CF1AC42}"/>
              </a:ext>
            </a:extLst>
          </p:cNvPr>
          <p:cNvSpPr txBox="1"/>
          <p:nvPr/>
        </p:nvSpPr>
        <p:spPr>
          <a:xfrm>
            <a:off x="4652582" y="1288446"/>
            <a:ext cx="11112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Grm7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KO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</a:p>
        </p:txBody>
      </p:sp>
      <p:sp>
        <p:nvSpPr>
          <p:cNvPr id="22" name="Right Bracket 21">
            <a:extLst>
              <a:ext uri="{FF2B5EF4-FFF2-40B4-BE49-F238E27FC236}">
                <a16:creationId xmlns:a16="http://schemas.microsoft.com/office/drawing/2014/main" xmlns="" id="{F3BCA434-45CD-9130-6671-D94E4E05A583}"/>
              </a:ext>
            </a:extLst>
          </p:cNvPr>
          <p:cNvSpPr/>
          <p:nvPr/>
        </p:nvSpPr>
        <p:spPr>
          <a:xfrm rot="16200000">
            <a:off x="2513486" y="1272294"/>
            <a:ext cx="109728" cy="137160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ight Bracket 22">
            <a:extLst>
              <a:ext uri="{FF2B5EF4-FFF2-40B4-BE49-F238E27FC236}">
                <a16:creationId xmlns:a16="http://schemas.microsoft.com/office/drawing/2014/main" xmlns="" id="{4FD06F6C-F221-A36B-EE1C-DB63658881E7}"/>
              </a:ext>
            </a:extLst>
          </p:cNvPr>
          <p:cNvSpPr/>
          <p:nvPr/>
        </p:nvSpPr>
        <p:spPr>
          <a:xfrm rot="16200000">
            <a:off x="4056105" y="1269662"/>
            <a:ext cx="109728" cy="137160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ight Bracket 23">
            <a:extLst>
              <a:ext uri="{FF2B5EF4-FFF2-40B4-BE49-F238E27FC236}">
                <a16:creationId xmlns:a16="http://schemas.microsoft.com/office/drawing/2014/main" xmlns="" id="{18FF7E30-5521-E44F-7924-CA6A5D9F993F}"/>
              </a:ext>
            </a:extLst>
          </p:cNvPr>
          <p:cNvSpPr/>
          <p:nvPr/>
        </p:nvSpPr>
        <p:spPr>
          <a:xfrm rot="16200000">
            <a:off x="5141582" y="1711356"/>
            <a:ext cx="133201" cy="46474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86E4FBF8-10E9-6A4D-B9F2-1199D3405FDB}"/>
              </a:ext>
            </a:extLst>
          </p:cNvPr>
          <p:cNvSpPr txBox="1"/>
          <p:nvPr/>
        </p:nvSpPr>
        <p:spPr>
          <a:xfrm>
            <a:off x="834463" y="196970"/>
            <a:ext cx="11164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. 2. Complete Western blots of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ecp2</a:t>
            </a:r>
            <a:r>
              <a:rPr lang="en-US" sz="1800" b="1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306C/+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ice cortical synaptosome samples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3001DAF8-5C0A-88A6-5F3A-14F6B075F0F0}"/>
              </a:ext>
            </a:extLst>
          </p:cNvPr>
          <p:cNvSpPr txBox="1"/>
          <p:nvPr/>
        </p:nvSpPr>
        <p:spPr>
          <a:xfrm>
            <a:off x="697972" y="855532"/>
            <a:ext cx="3652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0442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F5A097C1-5BF3-B25C-470D-C58D2D0FC7CA}"/>
              </a:ext>
            </a:extLst>
          </p:cNvPr>
          <p:cNvSpPr/>
          <p:nvPr/>
        </p:nvSpPr>
        <p:spPr>
          <a:xfrm>
            <a:off x="442847" y="2611096"/>
            <a:ext cx="113457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ono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1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D7131882-6358-E49F-EE55-D28AAF947989}"/>
              </a:ext>
            </a:extLst>
          </p:cNvPr>
          <p:cNvSpPr/>
          <p:nvPr/>
        </p:nvSpPr>
        <p:spPr>
          <a:xfrm>
            <a:off x="442847" y="2095823"/>
            <a:ext cx="113457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i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2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Isosceles Triangle 4">
            <a:extLst>
              <a:ext uri="{FF2B5EF4-FFF2-40B4-BE49-F238E27FC236}">
                <a16:creationId xmlns:a16="http://schemas.microsoft.com/office/drawing/2014/main" xmlns="" id="{19FEB9B7-976B-7C38-DDD4-F5B27CFB3C4D}"/>
              </a:ext>
            </a:extLst>
          </p:cNvPr>
          <p:cNvSpPr/>
          <p:nvPr/>
        </p:nvSpPr>
        <p:spPr>
          <a:xfrm rot="5400000" flipH="1">
            <a:off x="1439412" y="2776892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Isosceles Triangle 5">
            <a:extLst>
              <a:ext uri="{FF2B5EF4-FFF2-40B4-BE49-F238E27FC236}">
                <a16:creationId xmlns:a16="http://schemas.microsoft.com/office/drawing/2014/main" xmlns="" id="{8F5C3455-9EE4-39F0-9089-842E00FB01E0}"/>
              </a:ext>
            </a:extLst>
          </p:cNvPr>
          <p:cNvSpPr/>
          <p:nvPr/>
        </p:nvSpPr>
        <p:spPr>
          <a:xfrm rot="5400000" flipH="1">
            <a:off x="1439412" y="2261619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240F021F-C074-F60E-16B6-1ACB92CCA4FA}"/>
              </a:ext>
            </a:extLst>
          </p:cNvPr>
          <p:cNvSpPr txBox="1"/>
          <p:nvPr/>
        </p:nvSpPr>
        <p:spPr>
          <a:xfrm>
            <a:off x="2479152" y="1540492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E167C41A-46B2-0F6D-29F6-47B5CFE23C40}"/>
              </a:ext>
            </a:extLst>
          </p:cNvPr>
          <p:cNvSpPr txBox="1"/>
          <p:nvPr/>
        </p:nvSpPr>
        <p:spPr>
          <a:xfrm>
            <a:off x="3844020" y="1540492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306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F5DD52A-9707-8CD9-4A57-543B4BC4AA3D}"/>
              </a:ext>
            </a:extLst>
          </p:cNvPr>
          <p:cNvSpPr txBox="1"/>
          <p:nvPr/>
        </p:nvSpPr>
        <p:spPr>
          <a:xfrm>
            <a:off x="4766462" y="1294271"/>
            <a:ext cx="11112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Grm7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KO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</a:p>
        </p:txBody>
      </p:sp>
      <p:sp>
        <p:nvSpPr>
          <p:cNvPr id="10" name="Right Bracket 9">
            <a:extLst>
              <a:ext uri="{FF2B5EF4-FFF2-40B4-BE49-F238E27FC236}">
                <a16:creationId xmlns:a16="http://schemas.microsoft.com/office/drawing/2014/main" xmlns="" id="{4F3F96E0-0059-8E25-3DFC-E886242351F2}"/>
              </a:ext>
            </a:extLst>
          </p:cNvPr>
          <p:cNvSpPr/>
          <p:nvPr/>
        </p:nvSpPr>
        <p:spPr>
          <a:xfrm rot="16200000">
            <a:off x="2689769" y="1305660"/>
            <a:ext cx="112834" cy="128016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ight Bracket 10">
            <a:extLst>
              <a:ext uri="{FF2B5EF4-FFF2-40B4-BE49-F238E27FC236}">
                <a16:creationId xmlns:a16="http://schemas.microsoft.com/office/drawing/2014/main" xmlns="" id="{A5B1CD2C-A0D1-51EF-A7F3-0C672574EE36}"/>
              </a:ext>
            </a:extLst>
          </p:cNvPr>
          <p:cNvSpPr/>
          <p:nvPr/>
        </p:nvSpPr>
        <p:spPr>
          <a:xfrm rot="16200000">
            <a:off x="4216279" y="1304106"/>
            <a:ext cx="109728" cy="128016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ight Bracket 11">
            <a:extLst>
              <a:ext uri="{FF2B5EF4-FFF2-40B4-BE49-F238E27FC236}">
                <a16:creationId xmlns:a16="http://schemas.microsoft.com/office/drawing/2014/main" xmlns="" id="{16E468A8-F13F-4838-20E3-06403DCA42C2}"/>
              </a:ext>
            </a:extLst>
          </p:cNvPr>
          <p:cNvSpPr/>
          <p:nvPr/>
        </p:nvSpPr>
        <p:spPr>
          <a:xfrm rot="16200000">
            <a:off x="5267199" y="1678097"/>
            <a:ext cx="109728" cy="54864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78C42E89-980F-4530-DF53-0E0E96421D5F}"/>
              </a:ext>
            </a:extLst>
          </p:cNvPr>
          <p:cNvSpPr txBox="1"/>
          <p:nvPr/>
        </p:nvSpPr>
        <p:spPr>
          <a:xfrm>
            <a:off x="3018468" y="868731"/>
            <a:ext cx="1372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Glu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Blo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248A75CF-E92E-A971-1AEA-0779CAEF8C57}"/>
              </a:ext>
            </a:extLst>
          </p:cNvPr>
          <p:cNvSpPr txBox="1"/>
          <p:nvPr/>
        </p:nvSpPr>
        <p:spPr>
          <a:xfrm>
            <a:off x="8666687" y="868731"/>
            <a:ext cx="1514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ubulin Blot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5EA097D0-2314-74CD-D558-E844D151ED4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19000" contrast="85000"/>
                    </a14:imgEffect>
                  </a14:imgLayer>
                </a14:imgProps>
              </a:ext>
            </a:extLst>
          </a:blip>
          <a:srcRect l="3301" r="1851" b="22353"/>
          <a:stretch/>
        </p:blipFill>
        <p:spPr>
          <a:xfrm>
            <a:off x="1669907" y="2125240"/>
            <a:ext cx="4059699" cy="2084832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D9BBD99D-7C6C-A8CE-50AF-E3AB995D6066}"/>
              </a:ext>
            </a:extLst>
          </p:cNvPr>
          <p:cNvSpPr txBox="1"/>
          <p:nvPr/>
        </p:nvSpPr>
        <p:spPr>
          <a:xfrm>
            <a:off x="8192675" y="1540492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E683C449-68DF-ADC4-8889-8CF7D20BF2F7}"/>
              </a:ext>
            </a:extLst>
          </p:cNvPr>
          <p:cNvSpPr txBox="1"/>
          <p:nvPr/>
        </p:nvSpPr>
        <p:spPr>
          <a:xfrm>
            <a:off x="9557543" y="1540492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306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D916F857-145B-6BA4-9BFC-3A0D228DA685}"/>
              </a:ext>
            </a:extLst>
          </p:cNvPr>
          <p:cNvSpPr txBox="1"/>
          <p:nvPr/>
        </p:nvSpPr>
        <p:spPr>
          <a:xfrm>
            <a:off x="10455044" y="1294271"/>
            <a:ext cx="11112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Grm7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KO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</a:p>
        </p:txBody>
      </p:sp>
      <p:sp>
        <p:nvSpPr>
          <p:cNvPr id="19" name="Right Bracket 18">
            <a:extLst>
              <a:ext uri="{FF2B5EF4-FFF2-40B4-BE49-F238E27FC236}">
                <a16:creationId xmlns:a16="http://schemas.microsoft.com/office/drawing/2014/main" xmlns="" id="{252A3075-6F24-3C05-72E0-A0BDF2F8005E}"/>
              </a:ext>
            </a:extLst>
          </p:cNvPr>
          <p:cNvSpPr/>
          <p:nvPr/>
        </p:nvSpPr>
        <p:spPr>
          <a:xfrm rot="16200000">
            <a:off x="8388090" y="1320862"/>
            <a:ext cx="112834" cy="1249756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ight Bracket 19">
            <a:extLst>
              <a:ext uri="{FF2B5EF4-FFF2-40B4-BE49-F238E27FC236}">
                <a16:creationId xmlns:a16="http://schemas.microsoft.com/office/drawing/2014/main" xmlns="" id="{3D82ABDB-B1A4-6574-0FC1-0E04DD2ABE03}"/>
              </a:ext>
            </a:extLst>
          </p:cNvPr>
          <p:cNvSpPr/>
          <p:nvPr/>
        </p:nvSpPr>
        <p:spPr>
          <a:xfrm rot="16200000">
            <a:off x="9888270" y="1319307"/>
            <a:ext cx="109728" cy="1249756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Bracket 20">
            <a:extLst>
              <a:ext uri="{FF2B5EF4-FFF2-40B4-BE49-F238E27FC236}">
                <a16:creationId xmlns:a16="http://schemas.microsoft.com/office/drawing/2014/main" xmlns="" id="{EE61D425-95C0-2513-5F91-CBC377340898}"/>
              </a:ext>
            </a:extLst>
          </p:cNvPr>
          <p:cNvSpPr/>
          <p:nvPr/>
        </p:nvSpPr>
        <p:spPr>
          <a:xfrm rot="16200000">
            <a:off x="10930842" y="1711815"/>
            <a:ext cx="109728" cy="46474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xmlns="" id="{80E6D91F-7E11-CCBB-E32B-B7CCAAEF09C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1135" t="541" r="1478" b="8358"/>
          <a:stretch/>
        </p:blipFill>
        <p:spPr>
          <a:xfrm>
            <a:off x="7383699" y="2126361"/>
            <a:ext cx="3965303" cy="208371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xmlns="" id="{37BB45D9-3C08-48AD-FA4B-B030F30791DB}"/>
              </a:ext>
            </a:extLst>
          </p:cNvPr>
          <p:cNvSpPr/>
          <p:nvPr/>
        </p:nvSpPr>
        <p:spPr>
          <a:xfrm>
            <a:off x="6318820" y="3047206"/>
            <a:ext cx="91786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5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4" name="Isosceles Triangle 23">
            <a:extLst>
              <a:ext uri="{FF2B5EF4-FFF2-40B4-BE49-F238E27FC236}">
                <a16:creationId xmlns:a16="http://schemas.microsoft.com/office/drawing/2014/main" xmlns="" id="{5041A78B-39A3-68AE-3D8F-B14E14752297}"/>
              </a:ext>
            </a:extLst>
          </p:cNvPr>
          <p:cNvSpPr/>
          <p:nvPr/>
        </p:nvSpPr>
        <p:spPr>
          <a:xfrm rot="5400000" flipH="1">
            <a:off x="7167348" y="3213002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DAD47A30-7107-C3FA-65F5-816EB27C1DB8}"/>
              </a:ext>
            </a:extLst>
          </p:cNvPr>
          <p:cNvSpPr txBox="1"/>
          <p:nvPr/>
        </p:nvSpPr>
        <p:spPr>
          <a:xfrm>
            <a:off x="602030" y="228564"/>
            <a:ext cx="11433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. 3. Complete Western blots of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ecp2</a:t>
            </a:r>
            <a:r>
              <a:rPr lang="en-US" sz="1800" b="1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306C/+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ice cerebellar synaptosome samples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11BC99CD-3826-58F2-B79C-423DB30E9208}"/>
              </a:ext>
            </a:extLst>
          </p:cNvPr>
          <p:cNvSpPr txBox="1"/>
          <p:nvPr/>
        </p:nvSpPr>
        <p:spPr>
          <a:xfrm>
            <a:off x="697972" y="855532"/>
            <a:ext cx="3652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63243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7256081C-3EDE-1B6F-5E3E-52EDDF15E800}"/>
              </a:ext>
            </a:extLst>
          </p:cNvPr>
          <p:cNvSpPr/>
          <p:nvPr/>
        </p:nvSpPr>
        <p:spPr>
          <a:xfrm>
            <a:off x="351414" y="2785669"/>
            <a:ext cx="113457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ono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1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AE0E0BA5-2165-B2C4-EF9A-BDB09EE04F6F}"/>
              </a:ext>
            </a:extLst>
          </p:cNvPr>
          <p:cNvSpPr/>
          <p:nvPr/>
        </p:nvSpPr>
        <p:spPr>
          <a:xfrm>
            <a:off x="351414" y="2203892"/>
            <a:ext cx="113457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imer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20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5D406430-1126-D0A3-CF54-64A01B231A64}"/>
              </a:ext>
            </a:extLst>
          </p:cNvPr>
          <p:cNvSpPr/>
          <p:nvPr/>
        </p:nvSpPr>
        <p:spPr>
          <a:xfrm>
            <a:off x="6024180" y="3446216"/>
            <a:ext cx="91786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50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6" name="Isosceles Triangle 5">
            <a:extLst>
              <a:ext uri="{FF2B5EF4-FFF2-40B4-BE49-F238E27FC236}">
                <a16:creationId xmlns:a16="http://schemas.microsoft.com/office/drawing/2014/main" xmlns="" id="{611D39A0-A400-4AF3-1984-D5C402E018D2}"/>
              </a:ext>
            </a:extLst>
          </p:cNvPr>
          <p:cNvSpPr/>
          <p:nvPr/>
        </p:nvSpPr>
        <p:spPr>
          <a:xfrm rot="5400000" flipH="1">
            <a:off x="6872708" y="3612012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Isosceles Triangle 6">
            <a:extLst>
              <a:ext uri="{FF2B5EF4-FFF2-40B4-BE49-F238E27FC236}">
                <a16:creationId xmlns:a16="http://schemas.microsoft.com/office/drawing/2014/main" xmlns="" id="{8AD475F6-F581-2B28-70C2-23AA2C758C21}"/>
              </a:ext>
            </a:extLst>
          </p:cNvPr>
          <p:cNvSpPr/>
          <p:nvPr/>
        </p:nvSpPr>
        <p:spPr>
          <a:xfrm rot="5400000" flipH="1">
            <a:off x="1323037" y="2907075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Isosceles Triangle 7">
            <a:extLst>
              <a:ext uri="{FF2B5EF4-FFF2-40B4-BE49-F238E27FC236}">
                <a16:creationId xmlns:a16="http://schemas.microsoft.com/office/drawing/2014/main" xmlns="" id="{FEE7C763-CE7A-6EAA-36E9-ACCA7C3F6BC1}"/>
              </a:ext>
            </a:extLst>
          </p:cNvPr>
          <p:cNvSpPr/>
          <p:nvPr/>
        </p:nvSpPr>
        <p:spPr>
          <a:xfrm rot="5400000" flipH="1">
            <a:off x="1323037" y="2351932"/>
            <a:ext cx="157942" cy="19162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B194A440-E649-5DC4-4461-400716164670}"/>
              </a:ext>
            </a:extLst>
          </p:cNvPr>
          <p:cNvSpPr txBox="1"/>
          <p:nvPr/>
        </p:nvSpPr>
        <p:spPr>
          <a:xfrm>
            <a:off x="2296268" y="1540492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2389E3B4-08D4-D006-8979-BF9F5FB4999A}"/>
              </a:ext>
            </a:extLst>
          </p:cNvPr>
          <p:cNvSpPr txBox="1"/>
          <p:nvPr/>
        </p:nvSpPr>
        <p:spPr>
          <a:xfrm>
            <a:off x="3620170" y="1540492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306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CB5F8394-8A0F-456D-C2C7-F0F21713F542}"/>
              </a:ext>
            </a:extLst>
          </p:cNvPr>
          <p:cNvSpPr txBox="1"/>
          <p:nvPr/>
        </p:nvSpPr>
        <p:spPr>
          <a:xfrm>
            <a:off x="4653626" y="1294271"/>
            <a:ext cx="11112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Grm7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KO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</a:p>
        </p:txBody>
      </p:sp>
      <p:sp>
        <p:nvSpPr>
          <p:cNvPr id="12" name="Right Bracket 11">
            <a:extLst>
              <a:ext uri="{FF2B5EF4-FFF2-40B4-BE49-F238E27FC236}">
                <a16:creationId xmlns:a16="http://schemas.microsoft.com/office/drawing/2014/main" xmlns="" id="{4A4D389A-1329-1A0A-9997-9BCC1A46BEBF}"/>
              </a:ext>
            </a:extLst>
          </p:cNvPr>
          <p:cNvSpPr/>
          <p:nvPr/>
        </p:nvSpPr>
        <p:spPr>
          <a:xfrm rot="16200000">
            <a:off x="2491683" y="1361562"/>
            <a:ext cx="112834" cy="118872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ight Bracket 12">
            <a:extLst>
              <a:ext uri="{FF2B5EF4-FFF2-40B4-BE49-F238E27FC236}">
                <a16:creationId xmlns:a16="http://schemas.microsoft.com/office/drawing/2014/main" xmlns="" id="{634B1A0F-DC24-A5FC-009C-7EF5C3658F60}"/>
              </a:ext>
            </a:extLst>
          </p:cNvPr>
          <p:cNvSpPr/>
          <p:nvPr/>
        </p:nvSpPr>
        <p:spPr>
          <a:xfrm rot="16200000">
            <a:off x="3973928" y="1281858"/>
            <a:ext cx="109728" cy="137160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ight Bracket 13">
            <a:extLst>
              <a:ext uri="{FF2B5EF4-FFF2-40B4-BE49-F238E27FC236}">
                <a16:creationId xmlns:a16="http://schemas.microsoft.com/office/drawing/2014/main" xmlns="" id="{434A5F87-B2AE-3ADA-4647-8982F2FA2E8E}"/>
              </a:ext>
            </a:extLst>
          </p:cNvPr>
          <p:cNvSpPr/>
          <p:nvPr/>
        </p:nvSpPr>
        <p:spPr>
          <a:xfrm rot="16200000">
            <a:off x="5159519" y="1693339"/>
            <a:ext cx="109728" cy="54864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A64A5AA6-61C8-EE5D-18C2-536DE0A340E9}"/>
              </a:ext>
            </a:extLst>
          </p:cNvPr>
          <p:cNvSpPr txBox="1"/>
          <p:nvPr/>
        </p:nvSpPr>
        <p:spPr>
          <a:xfrm>
            <a:off x="3018468" y="868731"/>
            <a:ext cx="1372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Glu</a:t>
            </a:r>
            <a:r>
              <a:rPr lang="en-US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Blo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F1A86A1D-A814-8AF6-A09C-67F032030E53}"/>
              </a:ext>
            </a:extLst>
          </p:cNvPr>
          <p:cNvSpPr txBox="1"/>
          <p:nvPr/>
        </p:nvSpPr>
        <p:spPr>
          <a:xfrm>
            <a:off x="8666687" y="868731"/>
            <a:ext cx="1514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ubulin Blot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3B248616-5818-DE6C-04D2-B3C9646EA3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3202" y="2092578"/>
            <a:ext cx="4166688" cy="239749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3BAE21A1-7428-8A76-A62E-1EFE181A015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" r="3289" b="209"/>
          <a:stretch/>
        </p:blipFill>
        <p:spPr>
          <a:xfrm>
            <a:off x="7143203" y="2092579"/>
            <a:ext cx="4519554" cy="239659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4B027310-3269-311C-9C8D-E79CC7C95FB9}"/>
              </a:ext>
            </a:extLst>
          </p:cNvPr>
          <p:cNvSpPr txBox="1"/>
          <p:nvPr/>
        </p:nvSpPr>
        <p:spPr>
          <a:xfrm>
            <a:off x="8001568" y="1534991"/>
            <a:ext cx="5036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8401BAE8-7163-54EE-6DD3-B125CA907764}"/>
              </a:ext>
            </a:extLst>
          </p:cNvPr>
          <p:cNvSpPr txBox="1"/>
          <p:nvPr/>
        </p:nvSpPr>
        <p:spPr>
          <a:xfrm>
            <a:off x="9491728" y="1534991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306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2D2940FC-4EDB-EBCA-6DAA-64D0049AA681}"/>
              </a:ext>
            </a:extLst>
          </p:cNvPr>
          <p:cNvSpPr txBox="1"/>
          <p:nvPr/>
        </p:nvSpPr>
        <p:spPr>
          <a:xfrm>
            <a:off x="10666501" y="1288770"/>
            <a:ext cx="111120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Grm7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KO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</a:p>
        </p:txBody>
      </p:sp>
      <p:sp>
        <p:nvSpPr>
          <p:cNvPr id="22" name="Right Bracket 21">
            <a:extLst>
              <a:ext uri="{FF2B5EF4-FFF2-40B4-BE49-F238E27FC236}">
                <a16:creationId xmlns:a16="http://schemas.microsoft.com/office/drawing/2014/main" xmlns="" id="{17313881-6435-0AA9-D5DD-302496274664}"/>
              </a:ext>
            </a:extLst>
          </p:cNvPr>
          <p:cNvSpPr/>
          <p:nvPr/>
        </p:nvSpPr>
        <p:spPr>
          <a:xfrm rot="16200000">
            <a:off x="8196981" y="1264621"/>
            <a:ext cx="112834" cy="137160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ight Bracket 22">
            <a:extLst>
              <a:ext uri="{FF2B5EF4-FFF2-40B4-BE49-F238E27FC236}">
                <a16:creationId xmlns:a16="http://schemas.microsoft.com/office/drawing/2014/main" xmlns="" id="{429A1FB1-6F1A-54EB-446A-6313D9BCC911}"/>
              </a:ext>
            </a:extLst>
          </p:cNvPr>
          <p:cNvSpPr/>
          <p:nvPr/>
        </p:nvSpPr>
        <p:spPr>
          <a:xfrm rot="16200000">
            <a:off x="9874579" y="1129014"/>
            <a:ext cx="109728" cy="164592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ight Bracket 23">
            <a:extLst>
              <a:ext uri="{FF2B5EF4-FFF2-40B4-BE49-F238E27FC236}">
                <a16:creationId xmlns:a16="http://schemas.microsoft.com/office/drawing/2014/main" xmlns="" id="{650EEDF1-A364-F1A6-45DE-74E5220BB5D4}"/>
              </a:ext>
            </a:extLst>
          </p:cNvPr>
          <p:cNvSpPr/>
          <p:nvPr/>
        </p:nvSpPr>
        <p:spPr>
          <a:xfrm rot="16200000">
            <a:off x="11167238" y="1628827"/>
            <a:ext cx="109728" cy="640080"/>
          </a:xfrm>
          <a:prstGeom prst="righ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AC328A4F-DD5A-3CEE-B7DA-60367DC15B66}"/>
              </a:ext>
            </a:extLst>
          </p:cNvPr>
          <p:cNvSpPr txBox="1"/>
          <p:nvPr/>
        </p:nvSpPr>
        <p:spPr>
          <a:xfrm>
            <a:off x="351414" y="194001"/>
            <a:ext cx="11484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. 4. Complete Western blots of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ecp2</a:t>
            </a:r>
            <a:r>
              <a:rPr lang="en-US" sz="1800" b="1" i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306C/+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ice brainstem synaptosome samples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6E1009B2-2A2B-3C75-8F5D-3B65068C2846}"/>
              </a:ext>
            </a:extLst>
          </p:cNvPr>
          <p:cNvSpPr txBox="1"/>
          <p:nvPr/>
        </p:nvSpPr>
        <p:spPr>
          <a:xfrm>
            <a:off x="697972" y="855532"/>
            <a:ext cx="3652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033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2</TotalTime>
  <Words>184</Words>
  <Application>Microsoft Office PowerPoint</Application>
  <PresentationFormat>Widescreen</PresentationFormat>
  <Paragraphs>7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swender, Colleen</dc:creator>
  <cp:lastModifiedBy>Umamaheswari B</cp:lastModifiedBy>
  <cp:revision>113</cp:revision>
  <cp:lastPrinted>2025-12-10T18:55:22Z</cp:lastPrinted>
  <dcterms:created xsi:type="dcterms:W3CDTF">2024-07-26T17:04:26Z</dcterms:created>
  <dcterms:modified xsi:type="dcterms:W3CDTF">2026-01-30T03:06:19Z</dcterms:modified>
</cp:coreProperties>
</file>